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58"/>
  </p:normalViewPr>
  <p:slideViewPr>
    <p:cSldViewPr snapToGrid="0">
      <p:cViewPr varScale="1">
        <p:scale>
          <a:sx n="104" d="100"/>
          <a:sy n="104" d="100"/>
        </p:scale>
        <p:origin x="232" y="5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4F99F8-1B26-E0C4-E62A-F3C6D803E8B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66D1945-60F9-D2DD-458D-CD37F5D1AE8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C74F48B-0CED-D51A-F957-963C91D9F5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A51FC-4136-A64D-AFDD-B4DCE9D8E6C9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387AC9-F26A-D733-CE35-442AACC661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F1FC57A-FD6F-C46C-6285-F38975CAEC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C0180-AB5C-CE46-9B8D-6C01712982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90817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862910-13AE-729A-892F-7CBA93AEA5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E502C3D-9E89-A0D9-A7DD-3469527A2DF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83FE63-D15B-8BFD-E05F-B932099ED3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A51FC-4136-A64D-AFDD-B4DCE9D8E6C9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6F7C27-619E-379D-1197-82D9D306C5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EFE062-FC4A-4990-F330-ED4A995CFF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C0180-AB5C-CE46-9B8D-6C01712982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7197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7E714A5-0936-4820-6EBC-219169CACEF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ED1F220-C1C8-7EFB-A9D7-B88502542C4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9C050DC-2868-EF85-F322-06D6F79CF4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A51FC-4136-A64D-AFDD-B4DCE9D8E6C9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0DC944-16ED-DA36-CD4D-DCECFA6637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9BFB40-13C1-223B-0603-530D67D943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C0180-AB5C-CE46-9B8D-6C01712982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23654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3BF3CF-CE52-442A-086E-6C8E9E79F4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57AB9C8-8BC3-ED07-4304-73060DB4745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C8F121-0E14-D0F5-DA68-066958611E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A51FC-4136-A64D-AFDD-B4DCE9D8E6C9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0B3656-A0EF-330F-CAB6-D6E43AA782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5955D5-C721-861B-8F86-8A97E93166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C0180-AB5C-CE46-9B8D-6C01712982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04732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630E79-D11B-C85A-08CC-D1AAEBEA07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ACBC3E7-81CD-1E2D-B5D2-033E3D29CC7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CDA1A22-C9EB-5DCF-86C1-0A75B70C48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A51FC-4136-A64D-AFDD-B4DCE9D8E6C9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F15646C-BB13-F164-58BE-F9E028E99C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7882FF-A85D-771D-11E3-89F6D43B51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C0180-AB5C-CE46-9B8D-6C01712982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34413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745383-550F-75DA-69A3-E5CBD68E2E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50C94E9-5564-AB38-27EB-6C0AC975196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1D406A2-9C28-7089-1F08-17601E11305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03F46B8-6BD2-0E71-E072-465C8A63A7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A51FC-4136-A64D-AFDD-B4DCE9D8E6C9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FD9C812-8956-CD13-480D-3846A64877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C556D51-2385-AE69-FB6B-85D0C92F86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C0180-AB5C-CE46-9B8D-6C01712982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26223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00B4A4-5BBB-B07E-F7D6-7F5D51A7A1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64DDA4E-479F-FD5E-E1C3-DAF3F4C080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F418596-FBDA-8A7E-D3D1-88DE8986E1B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22934B6-FA64-57D8-12CF-DD48E68FCF5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B1E76B2-AEE0-0426-3E8C-70BE3539A92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10BE94F-4A28-437F-D80F-3AAB31F765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A51FC-4136-A64D-AFDD-B4DCE9D8E6C9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FE58E7F-3C6D-489E-BF54-01B1FAD7BD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327DF41-9AF6-6CF9-4D4A-447A830546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C0180-AB5C-CE46-9B8D-6C01712982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48795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8D003E-DB2F-F94D-1721-41B5A646ED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F9C3F12-CC2C-E7EE-5765-E70D6E0D15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A51FC-4136-A64D-AFDD-B4DCE9D8E6C9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46AAEDE-32F5-005E-83D5-84E3767661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F39141C-A450-A243-CF31-9A98030C99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C0180-AB5C-CE46-9B8D-6C01712982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55385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D822252-BB9F-10C6-EA72-A38B886329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A51FC-4136-A64D-AFDD-B4DCE9D8E6C9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181E690-9C7C-4788-01ED-01CCEA6147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835780B-4342-7BD8-DE8C-1FD28E17AF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C0180-AB5C-CE46-9B8D-6C01712982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23566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BDF048-FDA5-1435-B3E4-0478A9A450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0AFC783-C4DB-924C-D0BA-4AB7D83D4B6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D1AA0B1-C5E1-DB9E-047D-3144C7C0779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5C9A77F-3C20-F444-BF64-399C586AF4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A51FC-4136-A64D-AFDD-B4DCE9D8E6C9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D44EAD9-3A56-8111-8618-798F7372E0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D489136-405D-4B57-D1A4-BB7ECD53F4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C0180-AB5C-CE46-9B8D-6C01712982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11180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340D81-82C2-4BDF-8722-EEC2265B1D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28F810D-80CB-60D8-0511-932A1DF1D4E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3956DE6-FB15-D498-3AA8-7BE3FED7CFE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6188FB2-2668-DFFC-967E-8DA3B3F75C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A51FC-4136-A64D-AFDD-B4DCE9D8E6C9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9576C9D-2D14-BDEB-F992-70722C4F85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D234FAD-7D1D-C5C8-DF98-38E1B3DB27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C0180-AB5C-CE46-9B8D-6C01712982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06349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BDF03C3-3C6B-E0B2-8A92-71FDEFEE53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ADB2B54-55AD-3818-D0F8-506CE05FB8F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1BDB11-B9B0-FB33-40AF-844618CBB64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81A51FC-4136-A64D-AFDD-B4DCE9D8E6C9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EC15CD-A3EC-0D9E-B682-D058DD99408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9A6DDB-3A3B-7624-1B18-789BBB693B1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65C0180-AB5C-CE46-9B8D-6C01712982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28432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E728B441-01C5-6EA6-3C34-4122EC36DD2B}"/>
              </a:ext>
            </a:extLst>
          </p:cNvPr>
          <p:cNvSpPr txBox="1"/>
          <p:nvPr/>
        </p:nvSpPr>
        <p:spPr>
          <a:xfrm>
            <a:off x="610151" y="6178667"/>
            <a:ext cx="113424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upplemental Figure 8.</a:t>
            </a:r>
            <a:r>
              <a:rPr lang="en-US" sz="12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US" sz="1200" kern="100" dirty="0">
                <a:solidFill>
                  <a:schemeClr val="bg2">
                    <a:lumMod val="10000"/>
                  </a:schemeClr>
                </a:solidFill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Histogram comparison of expression of critical proteins identified in the analysi</a:t>
            </a:r>
            <a:r>
              <a:rPr lang="en-US" sz="1200" kern="100" dirty="0">
                <a:solidFill>
                  <a:schemeClr val="bg2">
                    <a:lumMod val="10000"/>
                  </a:schemeClr>
                </a:solidFill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 in comparison with health individuals ( SomaLogic provided healthy individuals aggregated data set).</a:t>
            </a:r>
            <a:endParaRPr lang="en-US" sz="1200" dirty="0">
              <a:solidFill>
                <a:schemeClr val="bg2">
                  <a:lumMod val="10000"/>
                </a:schemeClr>
              </a:solidFill>
            </a:endParaRP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05908125-46BD-DDA6-999B-0AA34F062C66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t="1414"/>
          <a:stretch>
            <a:fillRect/>
          </a:stretch>
        </p:blipFill>
        <p:spPr>
          <a:xfrm>
            <a:off x="1287478" y="360287"/>
            <a:ext cx="9987746" cy="58183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95885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9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rauze, Andra (NIH/NCI) [E]</dc:creator>
  <cp:lastModifiedBy>Krauze, Andra (NIH/NCI) [E]</cp:lastModifiedBy>
  <cp:revision>2</cp:revision>
  <dcterms:created xsi:type="dcterms:W3CDTF">2025-10-28T20:21:33Z</dcterms:created>
  <dcterms:modified xsi:type="dcterms:W3CDTF">2025-10-28T20:23:20Z</dcterms:modified>
</cp:coreProperties>
</file>